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1" autoAdjust="0"/>
    <p:restoredTop sz="94660"/>
  </p:normalViewPr>
  <p:slideViewPr>
    <p:cSldViewPr snapToGrid="0">
      <p:cViewPr varScale="1">
        <p:scale>
          <a:sx n="102" d="100"/>
          <a:sy n="102" d="100"/>
        </p:scale>
        <p:origin x="-114" y="-36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CB22F-BDAD-485B-9A8C-34C2EA5399E0}" type="datetimeFigureOut">
              <a:rPr lang="en-GB" smtClean="0"/>
              <a:t>15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64D0F-B338-4F29-9B6C-790745FC40F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96368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CB22F-BDAD-485B-9A8C-34C2EA5399E0}" type="datetimeFigureOut">
              <a:rPr lang="en-GB" smtClean="0"/>
              <a:t>15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64D0F-B338-4F29-9B6C-790745FC40F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4990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CB22F-BDAD-485B-9A8C-34C2EA5399E0}" type="datetimeFigureOut">
              <a:rPr lang="en-GB" smtClean="0"/>
              <a:t>15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64D0F-B338-4F29-9B6C-790745FC40F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30266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CB22F-BDAD-485B-9A8C-34C2EA5399E0}" type="datetimeFigureOut">
              <a:rPr lang="en-GB" smtClean="0"/>
              <a:t>15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64D0F-B338-4F29-9B6C-790745FC40F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56365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CB22F-BDAD-485B-9A8C-34C2EA5399E0}" type="datetimeFigureOut">
              <a:rPr lang="en-GB" smtClean="0"/>
              <a:t>15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64D0F-B338-4F29-9B6C-790745FC40F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91417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CB22F-BDAD-485B-9A8C-34C2EA5399E0}" type="datetimeFigureOut">
              <a:rPr lang="en-GB" smtClean="0"/>
              <a:t>15/11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64D0F-B338-4F29-9B6C-790745FC40F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8733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CB22F-BDAD-485B-9A8C-34C2EA5399E0}" type="datetimeFigureOut">
              <a:rPr lang="en-GB" smtClean="0"/>
              <a:t>15/11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64D0F-B338-4F29-9B6C-790745FC40F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07758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CB22F-BDAD-485B-9A8C-34C2EA5399E0}" type="datetimeFigureOut">
              <a:rPr lang="en-GB" smtClean="0"/>
              <a:t>15/11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64D0F-B338-4F29-9B6C-790745FC40F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88573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CB22F-BDAD-485B-9A8C-34C2EA5399E0}" type="datetimeFigureOut">
              <a:rPr lang="en-GB" smtClean="0"/>
              <a:t>15/11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64D0F-B338-4F29-9B6C-790745FC40F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9470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CB22F-BDAD-485B-9A8C-34C2EA5399E0}" type="datetimeFigureOut">
              <a:rPr lang="en-GB" smtClean="0"/>
              <a:t>15/11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64D0F-B338-4F29-9B6C-790745FC40F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08666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CB22F-BDAD-485B-9A8C-34C2EA5399E0}" type="datetimeFigureOut">
              <a:rPr lang="en-GB" smtClean="0"/>
              <a:t>15/11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64D0F-B338-4F29-9B6C-790745FC40F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90793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FCB22F-BDAD-485B-9A8C-34C2EA5399E0}" type="datetimeFigureOut">
              <a:rPr lang="en-GB" smtClean="0"/>
              <a:t>15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064D0F-B338-4F29-9B6C-790745FC40F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59414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12239" y="1133856"/>
            <a:ext cx="4576572" cy="3637788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7277100" y="1390650"/>
            <a:ext cx="3209925" cy="28007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u="sng" dirty="0"/>
              <a:t>Additional </a:t>
            </a:r>
            <a:r>
              <a:rPr lang="en-GB" sz="1600" u="sng"/>
              <a:t>File </a:t>
            </a:r>
            <a:r>
              <a:rPr lang="en-GB" sz="1600" u="sng" smtClean="0"/>
              <a:t>11 </a:t>
            </a:r>
            <a:r>
              <a:rPr lang="en-GB" sz="1600" dirty="0"/>
              <a:t>Changes in selected germ cell transcript levels following a single injection of </a:t>
            </a:r>
            <a:r>
              <a:rPr lang="en-GB" sz="1600" dirty="0" err="1"/>
              <a:t>busulfan</a:t>
            </a:r>
            <a:r>
              <a:rPr lang="en-GB" sz="1600" dirty="0"/>
              <a:t>. Results show mean ± SEM of between 3 and 5 animals in the </a:t>
            </a:r>
            <a:r>
              <a:rPr lang="en-GB" sz="1600" dirty="0" err="1"/>
              <a:t>busulfan</a:t>
            </a:r>
            <a:r>
              <a:rPr lang="en-GB" sz="1600" dirty="0"/>
              <a:t> treated groups  and 18 animals in the control group. Data were analysed by single factor </a:t>
            </a:r>
            <a:r>
              <a:rPr lang="en-GB" sz="1600" dirty="0" err="1"/>
              <a:t>anova</a:t>
            </a:r>
            <a:r>
              <a:rPr lang="en-GB" sz="1600" dirty="0"/>
              <a:t> and groups marked with an asterisk (*) are significantly different from control.</a:t>
            </a:r>
          </a:p>
        </p:txBody>
      </p:sp>
    </p:spTree>
    <p:extLst>
      <p:ext uri="{BB962C8B-B14F-4D97-AF65-F5344CB8AC3E}">
        <p14:creationId xmlns:p14="http://schemas.microsoft.com/office/powerpoint/2010/main" val="21199757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61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ter O'Shaughnessy</dc:creator>
  <cp:lastModifiedBy>pos1u</cp:lastModifiedBy>
  <cp:revision>3</cp:revision>
  <dcterms:created xsi:type="dcterms:W3CDTF">2017-08-08T12:35:03Z</dcterms:created>
  <dcterms:modified xsi:type="dcterms:W3CDTF">2017-11-15T14:55:27Z</dcterms:modified>
</cp:coreProperties>
</file>